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8" r:id="rId2"/>
    <p:sldId id="269" r:id="rId3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5170" autoAdjust="0"/>
  </p:normalViewPr>
  <p:slideViewPr>
    <p:cSldViewPr snapToGrid="0">
      <p:cViewPr varScale="1">
        <p:scale>
          <a:sx n="49" d="100"/>
          <a:sy n="49" d="100"/>
        </p:scale>
        <p:origin x="25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80E2E0-5DD8-4067-9DCE-61109EF940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427565"/>
            <a:ext cx="6858000" cy="1767417"/>
          </a:xfrm>
        </p:spPr>
        <p:txBody>
          <a:bodyPr>
            <a:normAutofit/>
          </a:bodyPr>
          <a:lstStyle/>
          <a:p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3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Adverse Events in the MIBC cohort regardless of attribution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CE13C28-98B4-47EC-AEE6-FBEB8CE5A7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594"/>
          <a:stretch/>
        </p:blipFill>
        <p:spPr>
          <a:xfrm>
            <a:off x="143691" y="888274"/>
            <a:ext cx="5839097" cy="7939870"/>
          </a:xfrm>
        </p:spPr>
      </p:pic>
    </p:spTree>
    <p:extLst>
      <p:ext uri="{BB962C8B-B14F-4D97-AF65-F5344CB8AC3E}">
        <p14:creationId xmlns:p14="http://schemas.microsoft.com/office/powerpoint/2010/main" val="3858897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5DED9-FCDB-4E15-8761-3DB04C0EEA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2665" y="-427564"/>
            <a:ext cx="5915025" cy="1767417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2: All Adverse Events in the MIBC cohort regardless of attribution continued</a:t>
            </a:r>
            <a:endParaRPr lang="en-US" sz="1400" dirty="0"/>
          </a:p>
        </p:txBody>
      </p:sp>
      <p:pic>
        <p:nvPicPr>
          <p:cNvPr id="5" name="Content Placeholder 4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912386D5-F3A1-4819-B2C5-7719EEB273E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2665" y="812288"/>
            <a:ext cx="6632251" cy="3550706"/>
          </a:xfrm>
        </p:spPr>
      </p:pic>
    </p:spTree>
    <p:extLst>
      <p:ext uri="{BB962C8B-B14F-4D97-AF65-F5344CB8AC3E}">
        <p14:creationId xmlns:p14="http://schemas.microsoft.com/office/powerpoint/2010/main" val="1753653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50</TotalTime>
  <Words>29</Words>
  <Application>Microsoft Office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 Table 3: All Adverse Events in the MIBC cohort regardless of attribution</vt:lpstr>
      <vt:lpstr>Supplement Table 2: All Adverse Events in the MIBC cohort regardless of attribution continue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5</cp:revision>
  <dcterms:created xsi:type="dcterms:W3CDTF">2023-03-30T22:39:16Z</dcterms:created>
  <dcterms:modified xsi:type="dcterms:W3CDTF">2024-08-15T22:23:27Z</dcterms:modified>
</cp:coreProperties>
</file>